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6" r:id="rId2"/>
    <p:sldId id="330" r:id="rId3"/>
    <p:sldId id="328" r:id="rId4"/>
    <p:sldId id="263" r:id="rId5"/>
    <p:sldId id="329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990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53F870-FF49-EDE8-6470-47AFFD1A0D0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55F0F9-EE96-5657-34B2-0FDB9BD7ED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492EC3-B6A2-0500-A1CC-4016A890F5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421083-39AF-26EC-0716-1C7DF94AF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CC9E87-2588-7035-5FA0-615F7A938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62726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65EB33-00A0-A104-1D65-80DBACE147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D1DD01-351D-5372-5E30-45D84AAB40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47841A-36DA-E913-3A65-556B2413B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C92B0F-4F01-BE90-E24C-1EBC1C258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882688-063A-405B-CB57-58B48A1D3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85539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A45BB33-7F27-A026-2FA2-6D5784C994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6923FB-1685-0260-FE95-BB03BDB628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FD43D9-3EFE-B82F-172D-BE3A685FA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51B8DF-DCBA-16E1-482C-AB6114194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CBAB81-2026-3ABA-6BA0-A0E91ECDA6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060547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2AFA4-4E57-033D-C745-64E0FD00C7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25F023-DC55-E37C-EA56-A4248D5693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7E6E42-B4DA-8695-F04D-0404C36E32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B2A011-F216-E039-BC1A-CC8C260DB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0D635A-1091-7286-7A93-13EA4234E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49178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F4137A-29C5-23A3-4DDF-BA96FA37A1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EBD35C-DE4B-D3CA-417A-4B7AC5529D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960C2C-BE78-DD61-3D1A-0B4BF4CE14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EF548E-B467-46FF-CAAA-2509A25FC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4D0786-12F2-8B20-74EE-CA903F1DB3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96485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C2F9B9-BB27-4335-EFD5-9871C9AF04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EB4B5D-4D8B-172E-E9BD-2F4556D816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56DC93-9935-6C46-ACAB-3456265367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623AB1-DF20-2ED0-2DEC-E157050FA6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2F886A-2201-440D-E61D-B114210EB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8FA0A8-48AF-0D84-28AA-5C97BB783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50639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B0A51F-CE01-4F08-FF2F-A3F2B48BAF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9E194C-5A28-3397-CF7E-74A38EA79C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E10575-10F0-582E-2C29-5D9F3F93E3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13259FD-D385-3D8C-DDFC-FB2752FBBF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18A37B-767A-2A23-18D2-7A4A3BD96E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086121B-57E8-3630-6259-D653B2868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A0C273-5AFF-BFE0-7E5C-30629D5EB6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E6B01D-9CC2-5CC7-996B-7746339066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95495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797E00-3C3D-EA76-727F-5445B7A907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48FD40F-D513-EB9A-9DDE-C228CFCF6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2AA123-A25D-6084-B33B-B20D74D9A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2646D0A-2244-6F24-F138-B715E7A26A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3273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2561400-E81F-AD8E-903B-9AD2C3970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251D8A-016C-6ADB-F13F-518829498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5A4411E-718D-BDC2-CB4E-F04A2CCD9C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52463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E2B310-A3CF-ADB3-45F9-C8C2EF2081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CE6DA7-07A0-4EB9-39FB-D97031102D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0ABCF0-41D2-293B-9AEB-3E0C6568E7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BE2889-B2D8-7BC5-2B50-B157D3CB7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9FA478-B010-0560-55DF-C1626518E5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BEA1EC-1897-6D8A-EFA6-B75A59983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39150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FE57F-8C37-D182-0A36-C4E61CD3F1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BA76903-0A96-F421-5442-1E7C932FA4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71A0DB-2741-98F6-729A-EE01ABE67F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B7C163-591C-D310-4EF7-1DED0B333D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BC81F8-7AD6-F2D4-45CF-0380E78009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940E1C-D36D-551D-04CF-139269A03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09670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74C082-1520-7EE8-2511-832B696DBD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8172AE-B8E9-A9E7-CB5A-F8F59D06FB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8BB689-1245-4192-C4C6-1499EA11D6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C96C03-1FF8-491F-86CD-A316386D0065}" type="datetimeFigureOut">
              <a:rPr lang="en-AU" smtClean="0"/>
              <a:t>12/01/2026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B3DB58-AFF2-DAE2-1A90-D7E34495E6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AB255E-0EEC-BE9F-38AB-508CA474668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622769-C054-4B1B-85BC-C3B3BF1D97E4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63844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20.emf"/><Relationship Id="rId3" Type="http://schemas.openxmlformats.org/officeDocument/2006/relationships/image" Target="../media/image15.emf"/><Relationship Id="rId7" Type="http://schemas.openxmlformats.org/officeDocument/2006/relationships/image" Target="../media/image17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19.emf"/><Relationship Id="rId5" Type="http://schemas.openxmlformats.org/officeDocument/2006/relationships/image" Target="../media/image16.emf"/><Relationship Id="rId15" Type="http://schemas.openxmlformats.org/officeDocument/2006/relationships/image" Target="../media/image21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18.emf"/><Relationship Id="rId14" Type="http://schemas.openxmlformats.org/officeDocument/2006/relationships/oleObject" Target="../embeddings/oleObject7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13" Type="http://schemas.openxmlformats.org/officeDocument/2006/relationships/image" Target="../media/image27.emf"/><Relationship Id="rId3" Type="http://schemas.openxmlformats.org/officeDocument/2006/relationships/image" Target="../media/image22.emf"/><Relationship Id="rId7" Type="http://schemas.openxmlformats.org/officeDocument/2006/relationships/image" Target="../media/image24.emf"/><Relationship Id="rId12" Type="http://schemas.openxmlformats.org/officeDocument/2006/relationships/oleObject" Target="../embeddings/oleObject13.bin"/><Relationship Id="rId17" Type="http://schemas.openxmlformats.org/officeDocument/2006/relationships/image" Target="../media/image29.emf"/><Relationship Id="rId2" Type="http://schemas.openxmlformats.org/officeDocument/2006/relationships/oleObject" Target="../embeddings/oleObject8.bin"/><Relationship Id="rId16" Type="http://schemas.openxmlformats.org/officeDocument/2006/relationships/oleObject" Target="../embeddings/oleObject1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0.bin"/><Relationship Id="rId11" Type="http://schemas.openxmlformats.org/officeDocument/2006/relationships/image" Target="../media/image26.emf"/><Relationship Id="rId5" Type="http://schemas.openxmlformats.org/officeDocument/2006/relationships/image" Target="../media/image23.emf"/><Relationship Id="rId15" Type="http://schemas.openxmlformats.org/officeDocument/2006/relationships/image" Target="../media/image28.emf"/><Relationship Id="rId10" Type="http://schemas.openxmlformats.org/officeDocument/2006/relationships/oleObject" Target="../embeddings/oleObject12.bin"/><Relationship Id="rId4" Type="http://schemas.openxmlformats.org/officeDocument/2006/relationships/oleObject" Target="../embeddings/oleObject9.bin"/><Relationship Id="rId9" Type="http://schemas.openxmlformats.org/officeDocument/2006/relationships/image" Target="../media/image25.emf"/><Relationship Id="rId14" Type="http://schemas.openxmlformats.org/officeDocument/2006/relationships/oleObject" Target="../embeddings/oleObject14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oleObject" Target="../embeddings/oleObject16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1.emf"/><Relationship Id="rId4" Type="http://schemas.openxmlformats.org/officeDocument/2006/relationships/oleObject" Target="../embeddings/oleObject1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9D28FB37-3A02-8DDA-A617-ABC75281F9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18851" y="2125618"/>
            <a:ext cx="2029632" cy="199791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5CA52BC-88DE-E956-BD57-E06A6D470137}"/>
              </a:ext>
            </a:extLst>
          </p:cNvPr>
          <p:cNvSpPr txBox="1"/>
          <p:nvPr/>
        </p:nvSpPr>
        <p:spPr>
          <a:xfrm>
            <a:off x="349976" y="5428899"/>
            <a:ext cx="6584031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693"/>
              </a:spcAft>
            </a:pP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G</a:t>
            </a:r>
            <a:r>
              <a:rPr lang="en-US" sz="1000" b="1" dirty="0" err="1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ing</a:t>
            </a:r>
            <a:r>
              <a:rPr lang="en-US" sz="1000" b="1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trategy 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ed to define the populations of interest in the flow cytometry experiments. After gating on CD3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 T cells within lymphocytes, CD45RA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R7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N</a:t>
            </a:r>
            <a:r>
              <a:rPr lang="en-US" sz="1000" baseline="-25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R7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, CD45RA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8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N</a:t>
            </a:r>
            <a:r>
              <a:rPr lang="en-US" sz="1000" baseline="-25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8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, and CD45RA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N</a:t>
            </a:r>
            <a:r>
              <a:rPr lang="en-US" sz="1000" baseline="-25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were defined</a:t>
            </a:r>
            <a:r>
              <a:rPr lang="en-AU" sz="1000" b="1" kern="1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AU" sz="1000" kern="1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 the 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000" baseline="-25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ubset, CD28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R7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ells and afterwards the CD57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bpopulation were gated. In this way, “true naïve” N</a:t>
            </a:r>
            <a:r>
              <a:rPr lang="en-US" sz="1000" baseline="-25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ere gated. Within the N</a:t>
            </a:r>
            <a:r>
              <a:rPr lang="en-US" sz="1000" baseline="-25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 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opulation, stem-like memory (T</a:t>
            </a:r>
            <a:r>
              <a:rPr lang="en-US" sz="1000" baseline="-25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M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CD45RA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8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R7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95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 were additionally defined.</a:t>
            </a:r>
            <a:endParaRPr lang="de-AT" sz="1000" kern="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DCED45EC-6667-7AAC-5F3A-1558EA5EE5A2}"/>
              </a:ext>
            </a:extLst>
          </p:cNvPr>
          <p:cNvGrpSpPr/>
          <p:nvPr/>
        </p:nvGrpSpPr>
        <p:grpSpPr>
          <a:xfrm>
            <a:off x="308977" y="111362"/>
            <a:ext cx="12846283" cy="6103637"/>
            <a:chOff x="552909" y="111368"/>
            <a:chExt cx="12846283" cy="6103637"/>
          </a:xfrm>
        </p:grpSpPr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C0E62B8F-CCCB-334C-B04E-B2574B23B1E4}"/>
                </a:ext>
              </a:extLst>
            </p:cNvPr>
            <p:cNvGrpSpPr/>
            <p:nvPr/>
          </p:nvGrpSpPr>
          <p:grpSpPr>
            <a:xfrm>
              <a:off x="552909" y="111368"/>
              <a:ext cx="10821015" cy="6103637"/>
              <a:chOff x="370114" y="201101"/>
              <a:chExt cx="12496769" cy="7048853"/>
            </a:xfrm>
          </p:grpSpPr>
          <p:pic>
            <p:nvPicPr>
              <p:cNvPr id="61" name="Picture 60">
                <a:extLst>
                  <a:ext uri="{FF2B5EF4-FFF2-40B4-BE49-F238E27FC236}">
                    <a16:creationId xmlns:a16="http://schemas.microsoft.com/office/drawing/2014/main" id="{D0BA5481-FFE9-81CF-61EC-676638DC52A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998876" y="3315421"/>
                <a:ext cx="2437306" cy="2421387"/>
              </a:xfrm>
              <a:prstGeom prst="rect">
                <a:avLst/>
              </a:prstGeom>
            </p:spPr>
          </p:pic>
          <p:pic>
            <p:nvPicPr>
              <p:cNvPr id="69" name="Picture 68">
                <a:extLst>
                  <a:ext uri="{FF2B5EF4-FFF2-40B4-BE49-F238E27FC236}">
                    <a16:creationId xmlns:a16="http://schemas.microsoft.com/office/drawing/2014/main" id="{AF65C83A-2499-FBD2-D564-4A4337478C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310140" y="3315421"/>
                <a:ext cx="2343951" cy="2421387"/>
              </a:xfrm>
              <a:prstGeom prst="rect">
                <a:avLst/>
              </a:prstGeom>
            </p:spPr>
          </p:pic>
          <p:grpSp>
            <p:nvGrpSpPr>
              <p:cNvPr id="75" name="Group 74">
                <a:extLst>
                  <a:ext uri="{FF2B5EF4-FFF2-40B4-BE49-F238E27FC236}">
                    <a16:creationId xmlns:a16="http://schemas.microsoft.com/office/drawing/2014/main" id="{EF98F75B-A287-A3DF-3429-3C0FFFE16C83}"/>
                  </a:ext>
                </a:extLst>
              </p:cNvPr>
              <p:cNvGrpSpPr/>
              <p:nvPr/>
            </p:nvGrpSpPr>
            <p:grpSpPr>
              <a:xfrm>
                <a:off x="370114" y="201101"/>
                <a:ext cx="12496769" cy="7048853"/>
                <a:chOff x="370114" y="201101"/>
                <a:chExt cx="12496769" cy="7048853"/>
              </a:xfrm>
            </p:grpSpPr>
            <p:grpSp>
              <p:nvGrpSpPr>
                <p:cNvPr id="74" name="Group 73">
                  <a:extLst>
                    <a:ext uri="{FF2B5EF4-FFF2-40B4-BE49-F238E27FC236}">
                      <a16:creationId xmlns:a16="http://schemas.microsoft.com/office/drawing/2014/main" id="{6670CDAB-6A64-E525-7402-645F4A0A35F2}"/>
                    </a:ext>
                  </a:extLst>
                </p:cNvPr>
                <p:cNvGrpSpPr/>
                <p:nvPr/>
              </p:nvGrpSpPr>
              <p:grpSpPr>
                <a:xfrm>
                  <a:off x="370114" y="201101"/>
                  <a:ext cx="12496769" cy="7048853"/>
                  <a:chOff x="370114" y="201101"/>
                  <a:chExt cx="12496769" cy="7048853"/>
                </a:xfrm>
              </p:grpSpPr>
              <p:grpSp>
                <p:nvGrpSpPr>
                  <p:cNvPr id="57" name="Group 56">
                    <a:extLst>
                      <a:ext uri="{FF2B5EF4-FFF2-40B4-BE49-F238E27FC236}">
                        <a16:creationId xmlns:a16="http://schemas.microsoft.com/office/drawing/2014/main" id="{543A521A-6C51-4AB5-EF98-3E5B5F6698D5}"/>
                      </a:ext>
                    </a:extLst>
                  </p:cNvPr>
                  <p:cNvGrpSpPr/>
                  <p:nvPr/>
                </p:nvGrpSpPr>
                <p:grpSpPr>
                  <a:xfrm>
                    <a:off x="370114" y="201101"/>
                    <a:ext cx="12157029" cy="7048853"/>
                    <a:chOff x="370114" y="201101"/>
                    <a:chExt cx="12157029" cy="7048853"/>
                  </a:xfrm>
                </p:grpSpPr>
                <p:grpSp>
                  <p:nvGrpSpPr>
                    <p:cNvPr id="28" name="Group 27">
                      <a:extLst>
                        <a:ext uri="{FF2B5EF4-FFF2-40B4-BE49-F238E27FC236}">
                          <a16:creationId xmlns:a16="http://schemas.microsoft.com/office/drawing/2014/main" id="{0289A4E3-C22E-15D0-1D54-B70112B0445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706371" y="201101"/>
                      <a:ext cx="4345933" cy="2307326"/>
                      <a:chOff x="5336256" y="73145"/>
                      <a:chExt cx="4345933" cy="2307326"/>
                    </a:xfrm>
                  </p:grpSpPr>
                  <p:grpSp>
                    <p:nvGrpSpPr>
                      <p:cNvPr id="26" name="Group 25">
                        <a:extLst>
                          <a:ext uri="{FF2B5EF4-FFF2-40B4-BE49-F238E27FC236}">
                            <a16:creationId xmlns:a16="http://schemas.microsoft.com/office/drawing/2014/main" id="{BA3083AC-A842-5094-EC4D-E90C867145E0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5336256" y="73145"/>
                        <a:ext cx="4345933" cy="2307326"/>
                        <a:chOff x="5336256" y="73145"/>
                        <a:chExt cx="4345933" cy="2307326"/>
                      </a:xfrm>
                    </p:grpSpPr>
                    <p:pic>
                      <p:nvPicPr>
                        <p:cNvPr id="16" name="Picture 15">
                          <a:extLst>
                            <a:ext uri="{FF2B5EF4-FFF2-40B4-BE49-F238E27FC236}">
                              <a16:creationId xmlns:a16="http://schemas.microsoft.com/office/drawing/2014/main" id="{3F00D61D-656F-0BFF-1F89-49EA1ED2D650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336256" y="73145"/>
                          <a:ext cx="2343950" cy="2307326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23" name="TextBox 22">
                          <a:extLst>
                            <a:ext uri="{FF2B5EF4-FFF2-40B4-BE49-F238E27FC236}">
                              <a16:creationId xmlns:a16="http://schemas.microsoft.com/office/drawing/2014/main" id="{B6891182-B71F-A73A-63D6-DE6562C8A70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7179019" y="871417"/>
                          <a:ext cx="2503170" cy="29131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AU" sz="1039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D8</a:t>
                          </a:r>
                          <a:r>
                            <a:rPr lang="en-AU" sz="1039" b="1" baseline="30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+</a:t>
                          </a:r>
                        </a:p>
                      </p:txBody>
                    </p:sp>
                  </p:grpSp>
                  <p:cxnSp>
                    <p:nvCxnSpPr>
                      <p:cNvPr id="17" name="Straight Arrow Connector 16">
                        <a:extLst>
                          <a:ext uri="{FF2B5EF4-FFF2-40B4-BE49-F238E27FC236}">
                            <a16:creationId xmlns:a16="http://schemas.microsoft.com/office/drawing/2014/main" id="{01B03B74-1E77-D541-A6D6-8EED904D212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7105171" y="1267342"/>
                        <a:ext cx="869905" cy="0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5" name="Group 4">
                      <a:extLst>
                        <a:ext uri="{FF2B5EF4-FFF2-40B4-BE49-F238E27FC236}">
                          <a16:creationId xmlns:a16="http://schemas.microsoft.com/office/drawing/2014/main" id="{299AA126-486D-33C0-E2C0-AAE7D6D9159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70114" y="201101"/>
                      <a:ext cx="3807714" cy="2307326"/>
                      <a:chOff x="93452" y="205121"/>
                      <a:chExt cx="3807714" cy="2307326"/>
                    </a:xfrm>
                  </p:grpSpPr>
                  <p:pic>
                    <p:nvPicPr>
                      <p:cNvPr id="3" name="Picture 2">
                        <a:extLst>
                          <a:ext uri="{FF2B5EF4-FFF2-40B4-BE49-F238E27FC236}">
                            <a16:creationId xmlns:a16="http://schemas.microsoft.com/office/drawing/2014/main" id="{D94AB937-E999-7570-956F-1DD6EB8FFDD5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3452" y="205121"/>
                        <a:ext cx="2395224" cy="2307326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4" name="TextBox 3">
                        <a:extLst>
                          <a:ext uri="{FF2B5EF4-FFF2-40B4-BE49-F238E27FC236}">
                            <a16:creationId xmlns:a16="http://schemas.microsoft.com/office/drawing/2014/main" id="{E5543602-61D5-E956-DFFF-8B8406423F0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397996" y="1925896"/>
                        <a:ext cx="2503170" cy="29131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AU" sz="1039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ymphocytes</a:t>
                        </a:r>
                      </a:p>
                    </p:txBody>
                  </p:sp>
                </p:grpSp>
                <p:grpSp>
                  <p:nvGrpSpPr>
                    <p:cNvPr id="29" name="Group 28">
                      <a:extLst>
                        <a:ext uri="{FF2B5EF4-FFF2-40B4-BE49-F238E27FC236}">
                          <a16:creationId xmlns:a16="http://schemas.microsoft.com/office/drawing/2014/main" id="{6950C338-4019-B8CF-5D84-9890088E67F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974193" y="201101"/>
                      <a:ext cx="4391466" cy="2307326"/>
                      <a:chOff x="2604079" y="73145"/>
                      <a:chExt cx="4391466" cy="2307326"/>
                    </a:xfrm>
                  </p:grpSpPr>
                  <p:pic>
                    <p:nvPicPr>
                      <p:cNvPr id="11" name="Picture 10">
                        <a:extLst>
                          <a:ext uri="{FF2B5EF4-FFF2-40B4-BE49-F238E27FC236}">
                            <a16:creationId xmlns:a16="http://schemas.microsoft.com/office/drawing/2014/main" id="{C7E9BE9F-04B8-CDCB-1068-8D60582FFC2E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604079" y="73145"/>
                        <a:ext cx="2343950" cy="2307326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12" name="TextBox 11">
                        <a:extLst>
                          <a:ext uri="{FF2B5EF4-FFF2-40B4-BE49-F238E27FC236}">
                            <a16:creationId xmlns:a16="http://schemas.microsoft.com/office/drawing/2014/main" id="{D3516F47-C9A6-CDDB-09EB-046A5C77C35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492375" y="1793920"/>
                        <a:ext cx="2503170" cy="291313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AU" sz="1039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live</a:t>
                        </a:r>
                      </a:p>
                    </p:txBody>
                  </p:sp>
                  <p:cxnSp>
                    <p:nvCxnSpPr>
                      <p:cNvPr id="13" name="Straight Arrow Connector 12">
                        <a:extLst>
                          <a:ext uri="{FF2B5EF4-FFF2-40B4-BE49-F238E27FC236}">
                            <a16:creationId xmlns:a16="http://schemas.microsoft.com/office/drawing/2014/main" id="{F16CA24D-7680-C5AB-D899-B98D08E5869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V="1">
                        <a:off x="4492375" y="1536569"/>
                        <a:ext cx="1427658" cy="257351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7" name="Straight Arrow Connector 6">
                      <a:extLst>
                        <a:ext uri="{FF2B5EF4-FFF2-40B4-BE49-F238E27FC236}">
                          <a16:creationId xmlns:a16="http://schemas.microsoft.com/office/drawing/2014/main" id="{A4A78FA8-2E66-82F6-E42A-63C370A15DF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978408" y="1722906"/>
                      <a:ext cx="1743959" cy="257351"/>
                    </a:xfrm>
                    <a:prstGeom prst="straightConnector1">
                      <a:avLst/>
                    </a:prstGeom>
                    <a:ln>
                      <a:tailEnd type="triangle"/>
                    </a:ln>
                  </p:spPr>
                  <p:style>
                    <a:lnRef idx="2">
                      <a:schemeClr val="dk1"/>
                    </a:lnRef>
                    <a:fillRef idx="0">
                      <a:schemeClr val="dk1"/>
                    </a:fillRef>
                    <a:effectRef idx="1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56" name="Group 55">
                      <a:extLst>
                        <a:ext uri="{FF2B5EF4-FFF2-40B4-BE49-F238E27FC236}">
                          <a16:creationId xmlns:a16="http://schemas.microsoft.com/office/drawing/2014/main" id="{A639CCA7-DBB6-C185-5CA8-88E068B8413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8438547" y="201101"/>
                      <a:ext cx="4088596" cy="7048853"/>
                      <a:chOff x="8438547" y="201101"/>
                      <a:chExt cx="4088596" cy="7048853"/>
                    </a:xfrm>
                  </p:grpSpPr>
                  <p:grpSp>
                    <p:nvGrpSpPr>
                      <p:cNvPr id="27" name="Group 26">
                        <a:extLst>
                          <a:ext uri="{FF2B5EF4-FFF2-40B4-BE49-F238E27FC236}">
                            <a16:creationId xmlns:a16="http://schemas.microsoft.com/office/drawing/2014/main" id="{91A51069-F71F-9955-427B-A98C5AAD88D7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8438547" y="201101"/>
                        <a:ext cx="4088596" cy="2307326"/>
                        <a:chOff x="8068433" y="73145"/>
                        <a:chExt cx="4088596" cy="2307326"/>
                      </a:xfrm>
                    </p:grpSpPr>
                    <p:pic>
                      <p:nvPicPr>
                        <p:cNvPr id="22" name="Picture 21">
                          <a:extLst>
                            <a:ext uri="{FF2B5EF4-FFF2-40B4-BE49-F238E27FC236}">
                              <a16:creationId xmlns:a16="http://schemas.microsoft.com/office/drawing/2014/main" id="{997FB900-7A6A-111F-BAFE-766E02CE071E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8068433" y="73145"/>
                          <a:ext cx="2343950" cy="2307326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25" name="TextBox 24">
                          <a:extLst>
                            <a:ext uri="{FF2B5EF4-FFF2-40B4-BE49-F238E27FC236}">
                              <a16:creationId xmlns:a16="http://schemas.microsoft.com/office/drawing/2014/main" id="{48E26B16-938C-B9C3-32E9-3504D93B2E4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9653859" y="949809"/>
                          <a:ext cx="2503170" cy="29131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AU" sz="1039" b="1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</a:t>
                          </a:r>
                          <a:r>
                            <a:rPr lang="en-AU" sz="1039" b="1" baseline="-25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D27</a:t>
                          </a:r>
                        </a:p>
                      </p:txBody>
                    </p:sp>
                  </p:grpSp>
                  <p:pic>
                    <p:nvPicPr>
                      <p:cNvPr id="42" name="Picture 41">
                        <a:extLst>
                          <a:ext uri="{FF2B5EF4-FFF2-40B4-BE49-F238E27FC236}">
                            <a16:creationId xmlns:a16="http://schemas.microsoft.com/office/drawing/2014/main" id="{8102D02D-F6DB-A550-CDFF-D8CF3098B13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8438547" y="2527280"/>
                        <a:ext cx="2343951" cy="2307326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39" name="Straight Arrow Connector 38">
                        <a:extLst>
                          <a:ext uri="{FF2B5EF4-FFF2-40B4-BE49-F238E27FC236}">
                            <a16:creationId xmlns:a16="http://schemas.microsoft.com/office/drawing/2014/main" id="{4623315C-83DA-1CFA-BC6E-681EFB469A26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780132" y="1483460"/>
                        <a:ext cx="0" cy="1858454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pic>
                    <p:nvPicPr>
                      <p:cNvPr id="53" name="Picture 52">
                        <a:extLst>
                          <a:ext uri="{FF2B5EF4-FFF2-40B4-BE49-F238E27FC236}">
                            <a16:creationId xmlns:a16="http://schemas.microsoft.com/office/drawing/2014/main" id="{83886B5B-DB23-4B58-3FF7-48BEA12B30FD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438547" y="4942628"/>
                        <a:ext cx="2343951" cy="2307326"/>
                      </a:xfrm>
                      <a:prstGeom prst="rect">
                        <a:avLst/>
                      </a:prstGeom>
                    </p:spPr>
                  </p:pic>
                  <p:cxnSp>
                    <p:nvCxnSpPr>
                      <p:cNvPr id="46" name="Straight Arrow Connector 45">
                        <a:extLst>
                          <a:ext uri="{FF2B5EF4-FFF2-40B4-BE49-F238E27FC236}">
                            <a16:creationId xmlns:a16="http://schemas.microsoft.com/office/drawing/2014/main" id="{B04F5ADD-3BC0-2127-38C5-4A2B2629E149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9780132" y="3960019"/>
                        <a:ext cx="0" cy="2255211"/>
                      </a:xfrm>
                      <a:prstGeom prst="straightConnector1">
                        <a:avLst/>
                      </a:prstGeom>
                      <a:ln>
                        <a:tailEnd type="triangle"/>
                      </a:ln>
                    </p:spPr>
                    <p:style>
                      <a:lnRef idx="2">
                        <a:schemeClr val="dk1"/>
                      </a:lnRef>
                      <a:fillRef idx="0">
                        <a:schemeClr val="dk1"/>
                      </a:fillRef>
                      <a:effectRef idx="1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sp>
                <p:nvSpPr>
                  <p:cNvPr id="59" name="TextBox 58">
                    <a:extLst>
                      <a:ext uri="{FF2B5EF4-FFF2-40B4-BE49-F238E27FC236}">
                        <a16:creationId xmlns:a16="http://schemas.microsoft.com/office/drawing/2014/main" id="{59169D10-588D-36F4-1964-479A2660F1AD}"/>
                      </a:ext>
                    </a:extLst>
                  </p:cNvPr>
                  <p:cNvSpPr txBox="1"/>
                  <p:nvPr/>
                </p:nvSpPr>
                <p:spPr>
                  <a:xfrm>
                    <a:off x="10363713" y="6540561"/>
                    <a:ext cx="2503170" cy="29131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1039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AU" sz="1039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N</a:t>
                    </a: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9B75E5E0-70AE-8FB2-B448-5F4F374A7E1C}"/>
                      </a:ext>
                    </a:extLst>
                  </p:cNvPr>
                  <p:cNvSpPr txBox="1"/>
                  <p:nvPr/>
                </p:nvSpPr>
                <p:spPr>
                  <a:xfrm>
                    <a:off x="6690972" y="4289985"/>
                    <a:ext cx="2503170" cy="29131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1039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AU" sz="1039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D28</a:t>
                    </a:r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BC7A8492-092A-3DA7-FB8A-92323730BFDB}"/>
                      </a:ext>
                    </a:extLst>
                  </p:cNvPr>
                  <p:cNvSpPr txBox="1"/>
                  <p:nvPr/>
                </p:nvSpPr>
                <p:spPr>
                  <a:xfrm>
                    <a:off x="3913077" y="4229202"/>
                    <a:ext cx="2503170" cy="29131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1039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  <a:r>
                      <a:rPr lang="en-AU" sz="1039" b="1" baseline="-25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CR7</a:t>
                    </a:r>
                  </a:p>
                </p:txBody>
              </p:sp>
            </p:grpSp>
            <p:cxnSp>
              <p:nvCxnSpPr>
                <p:cNvPr id="33" name="Straight Arrow Connector 32">
                  <a:extLst>
                    <a:ext uri="{FF2B5EF4-FFF2-40B4-BE49-F238E27FC236}">
                      <a16:creationId xmlns:a16="http://schemas.microsoft.com/office/drawing/2014/main" id="{A6200DC5-228B-F8F8-DF09-C1F04109AF9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521778" y="1666097"/>
                  <a:ext cx="744788" cy="2368109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Straight Arrow Connector 34">
                  <a:extLst>
                    <a:ext uri="{FF2B5EF4-FFF2-40B4-BE49-F238E27FC236}">
                      <a16:creationId xmlns:a16="http://schemas.microsoft.com/office/drawing/2014/main" id="{83210C14-9961-AD21-162C-BA7842AE58B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911838" y="1549620"/>
                  <a:ext cx="3136116" cy="2484586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cxnSp>
          <p:nvCxnSpPr>
            <p:cNvPr id="2" name="Straight Arrow Connector 1">
              <a:extLst>
                <a:ext uri="{FF2B5EF4-FFF2-40B4-BE49-F238E27FC236}">
                  <a16:creationId xmlns:a16="http://schemas.microsoft.com/office/drawing/2014/main" id="{00799D99-468E-5CA5-474D-C88B1E920347}"/>
                </a:ext>
              </a:extLst>
            </p:cNvPr>
            <p:cNvCxnSpPr>
              <a:cxnSpLocks/>
            </p:cNvCxnSpPr>
            <p:nvPr/>
          </p:nvCxnSpPr>
          <p:spPr>
            <a:xfrm>
              <a:off x="8912233" y="3254312"/>
              <a:ext cx="913645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3207D84-A9FD-17FF-9219-19681F5203A2}"/>
                </a:ext>
              </a:extLst>
            </p:cNvPr>
            <p:cNvSpPr txBox="1"/>
            <p:nvPr/>
          </p:nvSpPr>
          <p:spPr>
            <a:xfrm>
              <a:off x="11231684" y="2555824"/>
              <a:ext cx="2167508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39" b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lang="en-AU" sz="1039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SC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12926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>
            <a:extLst>
              <a:ext uri="{FF2B5EF4-FFF2-40B4-BE49-F238E27FC236}">
                <a16:creationId xmlns:a16="http://schemas.microsoft.com/office/drawing/2014/main" id="{DC7C45E7-2BA5-7163-2F54-6B550581E3EC}"/>
              </a:ext>
            </a:extLst>
          </p:cNvPr>
          <p:cNvSpPr/>
          <p:nvPr/>
        </p:nvSpPr>
        <p:spPr>
          <a:xfrm>
            <a:off x="9699171" y="4577533"/>
            <a:ext cx="215507" cy="47576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D7BE0E65-9396-6E40-E75A-A78E895E6B6B}"/>
              </a:ext>
            </a:extLst>
          </p:cNvPr>
          <p:cNvGrpSpPr/>
          <p:nvPr/>
        </p:nvGrpSpPr>
        <p:grpSpPr>
          <a:xfrm>
            <a:off x="243941" y="244553"/>
            <a:ext cx="12697774" cy="2199133"/>
            <a:chOff x="405866" y="4130753"/>
            <a:chExt cx="12697774" cy="2199133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FCFBE8C-5618-5276-3660-012F1A551E1D}"/>
                </a:ext>
              </a:extLst>
            </p:cNvPr>
            <p:cNvSpPr txBox="1"/>
            <p:nvPr/>
          </p:nvSpPr>
          <p:spPr>
            <a:xfrm>
              <a:off x="6204127" y="4130753"/>
              <a:ext cx="2167508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39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039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D27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A9CEFB1D-C470-445B-5362-40F2C9EBA766}"/>
                </a:ext>
              </a:extLst>
            </p:cNvPr>
            <p:cNvSpPr txBox="1"/>
            <p:nvPr/>
          </p:nvSpPr>
          <p:spPr>
            <a:xfrm>
              <a:off x="1472122" y="4130755"/>
              <a:ext cx="2167507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39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039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CR7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3934F8F-A05E-FC87-B47B-6305ECB8058A}"/>
                </a:ext>
              </a:extLst>
            </p:cNvPr>
            <p:cNvSpPr txBox="1"/>
            <p:nvPr/>
          </p:nvSpPr>
          <p:spPr>
            <a:xfrm>
              <a:off x="3888180" y="4130754"/>
              <a:ext cx="2167507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39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039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CD28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CDBFA69-5BB4-C24B-5B51-DFFC9FDA741C}"/>
                </a:ext>
              </a:extLst>
            </p:cNvPr>
            <p:cNvSpPr txBox="1"/>
            <p:nvPr/>
          </p:nvSpPr>
          <p:spPr>
            <a:xfrm>
              <a:off x="8620185" y="4130753"/>
              <a:ext cx="2167507" cy="252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039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en-AU" sz="1039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TN</a:t>
              </a:r>
            </a:p>
          </p:txBody>
        </p: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D1EA0290-9140-2F74-6B84-B88CF5558FF0}"/>
                </a:ext>
              </a:extLst>
            </p:cNvPr>
            <p:cNvGrpSpPr/>
            <p:nvPr/>
          </p:nvGrpSpPr>
          <p:grpSpPr>
            <a:xfrm>
              <a:off x="405866" y="4130753"/>
              <a:ext cx="12697774" cy="2199133"/>
              <a:chOff x="405866" y="4130753"/>
              <a:chExt cx="12697774" cy="2199133"/>
            </a:xfrm>
          </p:grpSpPr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48D59D79-C3E6-A40A-5DA7-252D3A903F28}"/>
                  </a:ext>
                </a:extLst>
              </p:cNvPr>
              <p:cNvGrpSpPr/>
              <p:nvPr/>
            </p:nvGrpSpPr>
            <p:grpSpPr>
              <a:xfrm>
                <a:off x="405866" y="4331965"/>
                <a:ext cx="10061954" cy="1997921"/>
                <a:chOff x="405866" y="4331965"/>
                <a:chExt cx="10061954" cy="1997921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7D293219-C0F8-B758-D515-F4EC40657F7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405866" y="4331967"/>
                  <a:ext cx="2098615" cy="1997919"/>
                </a:xfrm>
                <a:prstGeom prst="rect">
                  <a:avLst/>
                </a:prstGeom>
              </p:spPr>
            </p:pic>
            <p:pic>
              <p:nvPicPr>
                <p:cNvPr id="8" name="Picture 7">
                  <a:extLst>
                    <a:ext uri="{FF2B5EF4-FFF2-40B4-BE49-F238E27FC236}">
                      <a16:creationId xmlns:a16="http://schemas.microsoft.com/office/drawing/2014/main" id="{83BABA47-FF59-7340-EC96-5C9BB852918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2753032" y="4331966"/>
                  <a:ext cx="2170185" cy="1997919"/>
                </a:xfrm>
                <a:prstGeom prst="rect">
                  <a:avLst/>
                </a:prstGeom>
              </p:spPr>
            </p:pic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46F01326-E73D-72ED-6447-1C11CB8BDE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5119062" y="4331966"/>
                  <a:ext cx="2170185" cy="1997919"/>
                </a:xfrm>
                <a:prstGeom prst="rect">
                  <a:avLst/>
                </a:prstGeom>
              </p:spPr>
            </p:pic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B7334CB0-BC9B-7F56-8FD9-BB22DF9074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7485092" y="4331965"/>
                  <a:ext cx="2170184" cy="1997919"/>
                </a:xfrm>
                <a:prstGeom prst="rect">
                  <a:avLst/>
                </a:prstGeom>
              </p:spPr>
            </p:pic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F590E733-5D43-A183-3341-C0371484E822}"/>
                    </a:ext>
                  </a:extLst>
                </p:cNvPr>
                <p:cNvSpPr txBox="1"/>
                <p:nvPr/>
              </p:nvSpPr>
              <p:spPr>
                <a:xfrm>
                  <a:off x="1147389" y="5263055"/>
                  <a:ext cx="2167507" cy="5027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X3CR1</a:t>
                  </a:r>
                  <a:r>
                    <a:rPr lang="en-AU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AU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.7%</a:t>
                  </a:r>
                  <a:endParaRPr lang="en-AU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AU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EBF4FDCD-1A7A-03A7-AEE6-372032769387}"/>
                    </a:ext>
                  </a:extLst>
                </p:cNvPr>
                <p:cNvSpPr txBox="1"/>
                <p:nvPr/>
              </p:nvSpPr>
              <p:spPr>
                <a:xfrm>
                  <a:off x="3563447" y="5263055"/>
                  <a:ext cx="2167507" cy="5027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X3CR1</a:t>
                  </a:r>
                  <a:r>
                    <a:rPr lang="en-AU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AU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.5%</a:t>
                  </a:r>
                  <a:endParaRPr lang="en-AU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AU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7D87188A-B28D-C419-76E6-8569FE3C990C}"/>
                    </a:ext>
                  </a:extLst>
                </p:cNvPr>
                <p:cNvSpPr txBox="1"/>
                <p:nvPr/>
              </p:nvSpPr>
              <p:spPr>
                <a:xfrm>
                  <a:off x="5931880" y="5283299"/>
                  <a:ext cx="2167507" cy="5027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X3CR1</a:t>
                  </a:r>
                  <a:r>
                    <a:rPr lang="en-AU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AU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1%</a:t>
                  </a:r>
                  <a:endParaRPr lang="en-AU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AU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753783E9-BAA4-CE0C-631F-95119C56FB35}"/>
                    </a:ext>
                  </a:extLst>
                </p:cNvPr>
                <p:cNvSpPr txBox="1"/>
                <p:nvPr/>
              </p:nvSpPr>
              <p:spPr>
                <a:xfrm>
                  <a:off x="8300313" y="5283299"/>
                  <a:ext cx="2167507" cy="50270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AU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X3CR1</a:t>
                  </a:r>
                  <a:r>
                    <a:rPr lang="en-AU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</a:p>
                <a:p>
                  <a:pPr algn="ctr"/>
                  <a:r>
                    <a:rPr lang="en-AU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25%</a:t>
                  </a:r>
                  <a:endParaRPr lang="en-AU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endParaRPr lang="en-AU" sz="1000" b="1" baseline="30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id="{1C450DF4-440E-956F-BC83-5B87F802D0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9806924" y="4334718"/>
                <a:ext cx="2229158" cy="1995166"/>
              </a:xfrm>
              <a:prstGeom prst="rect">
                <a:avLst/>
              </a:prstGeom>
            </p:spPr>
          </p:pic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E2B497CF-C1DD-411D-2905-5B735F71991B}"/>
                  </a:ext>
                </a:extLst>
              </p:cNvPr>
              <p:cNvSpPr txBox="1"/>
              <p:nvPr/>
            </p:nvSpPr>
            <p:spPr>
              <a:xfrm>
                <a:off x="10936133" y="4130753"/>
                <a:ext cx="2167507" cy="2522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39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MO</a:t>
                </a:r>
                <a:endParaRPr lang="en-AU" sz="1039" b="1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D9EBA1AF-331F-79B5-BA6E-47388F0C8F4F}"/>
              </a:ext>
            </a:extLst>
          </p:cNvPr>
          <p:cNvSpPr txBox="1"/>
          <p:nvPr/>
        </p:nvSpPr>
        <p:spPr>
          <a:xfrm>
            <a:off x="244212" y="2800097"/>
            <a:ext cx="11852538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693"/>
              </a:spcAft>
            </a:pP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G</a:t>
            </a:r>
            <a:r>
              <a:rPr lang="en-US" sz="1000" b="1" dirty="0" err="1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ing</a:t>
            </a:r>
            <a:r>
              <a:rPr lang="en-US" sz="1000" b="1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trategy: representative FACS plots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Representative FACS plots showing CX3CR1 levels in the N</a:t>
            </a:r>
            <a:r>
              <a:rPr lang="en-US" sz="1000" baseline="-25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CR7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N</a:t>
            </a:r>
            <a:r>
              <a:rPr lang="en-US" sz="1000" baseline="-25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8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N</a:t>
            </a:r>
            <a:r>
              <a:rPr lang="en-US" sz="1000" baseline="-25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nd N</a:t>
            </a:r>
            <a:r>
              <a:rPr lang="en-US" sz="1000" baseline="-25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N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D8</a:t>
            </a:r>
            <a:r>
              <a:rPr lang="en-US" sz="1000" baseline="30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solidFill>
                  <a:srgbClr val="1C1D1E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 cell subsets in an old donor (aged 82 years old). A fluorescence minus one (FMO) control is additionally shown. </a:t>
            </a:r>
            <a:endParaRPr lang="de-AT" sz="1000" kern="1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49908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AA37E95-649B-F00F-CED3-7BDCB0C97E0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3109643"/>
              </p:ext>
            </p:extLst>
          </p:nvPr>
        </p:nvGraphicFramePr>
        <p:xfrm>
          <a:off x="199616" y="308123"/>
          <a:ext cx="2314867" cy="27767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768723" imgH="3322061" progId="Prism10.Document">
                  <p:embed/>
                </p:oleObj>
              </mc:Choice>
              <mc:Fallback>
                <p:oleObj name="Prism 10" r:id="rId2" imgW="2768723" imgH="3322061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1AA37E95-649B-F00F-CED3-7BDCB0C97E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99616" y="308123"/>
                        <a:ext cx="2314867" cy="27767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A6ECDF6-E7D9-8CDF-907F-9610B1725C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7564601"/>
              </p:ext>
            </p:extLst>
          </p:nvPr>
        </p:nvGraphicFramePr>
        <p:xfrm>
          <a:off x="2483180" y="426475"/>
          <a:ext cx="2409825" cy="2681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771604" imgH="3166834" progId="Prism10.Document">
                  <p:embed/>
                </p:oleObj>
              </mc:Choice>
              <mc:Fallback>
                <p:oleObj name="Prism 10" r:id="rId4" imgW="2771604" imgH="3166834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A6ECDF6-E7D9-8CDF-907F-9610B1725C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83180" y="426475"/>
                        <a:ext cx="2409825" cy="2681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6C4C0AF-7FD9-F083-B710-112DCEA620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3777734"/>
              </p:ext>
            </p:extLst>
          </p:nvPr>
        </p:nvGraphicFramePr>
        <p:xfrm>
          <a:off x="4775390" y="342439"/>
          <a:ext cx="2409825" cy="2747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771604" imgH="3166834" progId="Prism10.Document">
                  <p:embed/>
                </p:oleObj>
              </mc:Choice>
              <mc:Fallback>
                <p:oleObj name="Prism 10" r:id="rId6" imgW="2771604" imgH="3166834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6C4C0AF-7FD9-F083-B710-112DCEA6202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75390" y="342439"/>
                        <a:ext cx="2409825" cy="2747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85C3939-B805-08F4-A876-F43D614486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1287327"/>
              </p:ext>
            </p:extLst>
          </p:nvPr>
        </p:nvGraphicFramePr>
        <p:xfrm>
          <a:off x="2537415" y="2932431"/>
          <a:ext cx="2409912" cy="26480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2844712" imgH="3056987" progId="Prism10.Document">
                  <p:embed/>
                </p:oleObj>
              </mc:Choice>
              <mc:Fallback>
                <p:oleObj name="Prism 10" r:id="rId8" imgW="2844712" imgH="3056987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85C3939-B805-08F4-A876-F43D6144869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537415" y="2932431"/>
                        <a:ext cx="2409912" cy="26480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7D317414-FF29-DB74-8C1C-4B3297E9DB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42457151"/>
              </p:ext>
            </p:extLst>
          </p:nvPr>
        </p:nvGraphicFramePr>
        <p:xfrm>
          <a:off x="9411232" y="466394"/>
          <a:ext cx="2232390" cy="25293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2768723" imgH="3139103" progId="Prism10.Document">
                  <p:embed/>
                </p:oleObj>
              </mc:Choice>
              <mc:Fallback>
                <p:oleObj name="Prism 10" r:id="rId10" imgW="2768723" imgH="3139103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7D317414-FF29-DB74-8C1C-4B3297E9DB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9411232" y="466394"/>
                        <a:ext cx="2232390" cy="25293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E2421032-AF91-ADA7-C295-B9EDEBFC43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3125804"/>
              </p:ext>
            </p:extLst>
          </p:nvPr>
        </p:nvGraphicFramePr>
        <p:xfrm>
          <a:off x="7173344" y="409114"/>
          <a:ext cx="2237888" cy="26104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2768723" imgH="3230582" progId="Prism10.Document">
                  <p:embed/>
                </p:oleObj>
              </mc:Choice>
              <mc:Fallback>
                <p:oleObj name="Prism 10" r:id="rId12" imgW="2768723" imgH="3230582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E2421032-AF91-ADA7-C295-B9EDEBFC43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173344" y="409114"/>
                        <a:ext cx="2237888" cy="26104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D5C96530-BCAB-D061-73DF-5457F58C00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0376291"/>
              </p:ext>
            </p:extLst>
          </p:nvPr>
        </p:nvGraphicFramePr>
        <p:xfrm>
          <a:off x="182382" y="2900748"/>
          <a:ext cx="2411413" cy="2679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2783849" imgH="3239946" progId="Prism10.Document">
                  <p:embed/>
                </p:oleObj>
              </mc:Choice>
              <mc:Fallback>
                <p:oleObj name="Prism 10" r:id="rId14" imgW="2783849" imgH="3239946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D5C96530-BCAB-D061-73DF-5457F58C00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82382" y="2900748"/>
                        <a:ext cx="2411413" cy="2679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885B62D9-E4EB-5AFD-5EB9-FCFC99C6A7CC}"/>
              </a:ext>
            </a:extLst>
          </p:cNvPr>
          <p:cNvSpPr txBox="1"/>
          <p:nvPr/>
        </p:nvSpPr>
        <p:spPr>
          <a:xfrm>
            <a:off x="120950" y="484539"/>
            <a:ext cx="441756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385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8B65575-0ABD-71D4-AC04-6567B857EFC9}"/>
              </a:ext>
            </a:extLst>
          </p:cNvPr>
          <p:cNvSpPr txBox="1"/>
          <p:nvPr/>
        </p:nvSpPr>
        <p:spPr>
          <a:xfrm>
            <a:off x="2532907" y="482342"/>
            <a:ext cx="441756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385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7DBC10F-A956-3D9A-BAC4-F59F45EBEFC7}"/>
              </a:ext>
            </a:extLst>
          </p:cNvPr>
          <p:cNvSpPr txBox="1"/>
          <p:nvPr/>
        </p:nvSpPr>
        <p:spPr>
          <a:xfrm>
            <a:off x="4775303" y="466394"/>
            <a:ext cx="441756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385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8B0E08A-FF32-C143-A9F1-DC1CFA26D659}"/>
              </a:ext>
            </a:extLst>
          </p:cNvPr>
          <p:cNvSpPr txBox="1"/>
          <p:nvPr/>
        </p:nvSpPr>
        <p:spPr>
          <a:xfrm>
            <a:off x="2605579" y="3010895"/>
            <a:ext cx="441756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385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E6EC88D-A371-1C74-EB77-DB1936FB1E64}"/>
              </a:ext>
            </a:extLst>
          </p:cNvPr>
          <p:cNvSpPr txBox="1"/>
          <p:nvPr/>
        </p:nvSpPr>
        <p:spPr>
          <a:xfrm>
            <a:off x="7017699" y="471980"/>
            <a:ext cx="441756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385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FE83D3C-A067-07B9-B958-3836F03B40FD}"/>
              </a:ext>
            </a:extLst>
          </p:cNvPr>
          <p:cNvSpPr txBox="1"/>
          <p:nvPr/>
        </p:nvSpPr>
        <p:spPr>
          <a:xfrm>
            <a:off x="9373809" y="482342"/>
            <a:ext cx="441756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385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EA9C3D9-5FA3-A532-99BB-CEF01820C74B}"/>
              </a:ext>
            </a:extLst>
          </p:cNvPr>
          <p:cNvSpPr txBox="1"/>
          <p:nvPr/>
        </p:nvSpPr>
        <p:spPr>
          <a:xfrm>
            <a:off x="184236" y="3060552"/>
            <a:ext cx="441756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385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B56362F-44C7-AA36-A3F0-1034D1FF018A}"/>
              </a:ext>
            </a:extLst>
          </p:cNvPr>
          <p:cNvSpPr txBox="1"/>
          <p:nvPr/>
        </p:nvSpPr>
        <p:spPr>
          <a:xfrm>
            <a:off x="5217059" y="3391762"/>
            <a:ext cx="6679667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Differentiation markers, cytokines, effector molecules and SA-</a:t>
            </a:r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-gal in N</a:t>
            </a:r>
            <a:r>
              <a:rPr lang="en-AU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CCR7</a:t>
            </a:r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, N</a:t>
            </a:r>
            <a:r>
              <a:rPr lang="en-AU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CD28</a:t>
            </a:r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, N</a:t>
            </a:r>
            <a:r>
              <a:rPr lang="en-AU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CD27</a:t>
            </a:r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 , N</a:t>
            </a:r>
            <a:r>
              <a:rPr lang="en-AU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TN</a:t>
            </a:r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 and T</a:t>
            </a:r>
            <a:r>
              <a:rPr lang="en-AU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SCM</a:t>
            </a:r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 CD8</a:t>
            </a:r>
            <a:r>
              <a:rPr lang="en-AU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requency of 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AU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X3CR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CD16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NKp80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TNF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IFN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de-AT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n PBMCs stimulated with PMA, Ionomycin and BFA for 4h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GrzB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ells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SA-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-gal activity in the CD8</a:t>
            </a:r>
            <a:r>
              <a:rPr lang="en-AU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AU" sz="1000" dirty="0">
                <a:latin typeface="Arial" panose="020B0604020202020204" pitchFamily="34" charset="0"/>
                <a:cs typeface="Arial" panose="020B0604020202020204" pitchFamily="34" charset="0"/>
              </a:rPr>
              <a:t> T cell subsets. n=10 in each subset. Friedman test, Dunn’s post-hoc test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*p&lt;0.05; **p&lt;0.01; ***p&lt;0.001, ****p&lt;0.0001.</a:t>
            </a:r>
            <a:endParaRPr lang="de-A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06456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id="{BE71D49E-CBE6-0B82-B7BC-5FB304CFEFC6}"/>
              </a:ext>
            </a:extLst>
          </p:cNvPr>
          <p:cNvGrpSpPr/>
          <p:nvPr/>
        </p:nvGrpSpPr>
        <p:grpSpPr>
          <a:xfrm>
            <a:off x="794278" y="825082"/>
            <a:ext cx="10502165" cy="2001453"/>
            <a:chOff x="-26753" y="952855"/>
            <a:chExt cx="12128542" cy="2311400"/>
          </a:xfrm>
        </p:grpSpPr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9406AB81-19B2-208A-EAA5-7153B732E0E6}"/>
                </a:ext>
              </a:extLst>
            </p:cNvPr>
            <p:cNvGrpSpPr/>
            <p:nvPr/>
          </p:nvGrpSpPr>
          <p:grpSpPr>
            <a:xfrm>
              <a:off x="-26753" y="952855"/>
              <a:ext cx="12128542" cy="2311400"/>
              <a:chOff x="-159900" y="913607"/>
              <a:chExt cx="12128542" cy="2311400"/>
            </a:xfrm>
          </p:grpSpPr>
          <p:graphicFrame>
            <p:nvGraphicFramePr>
              <p:cNvPr id="2" name="Object 1">
                <a:extLst>
                  <a:ext uri="{FF2B5EF4-FFF2-40B4-BE49-F238E27FC236}">
                    <a16:creationId xmlns:a16="http://schemas.microsoft.com/office/drawing/2014/main" id="{76D0EED3-CCD0-4B93-3FD4-8A0069A8DDD4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8642830" y="919957"/>
              <a:ext cx="3325812" cy="23034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2" imgW="4063051" imgH="2965508" progId="Prism9.Document">
                      <p:embed/>
                    </p:oleObj>
                  </mc:Choice>
                  <mc:Fallback>
                    <p:oleObj name="Prism 9" r:id="rId2" imgW="4063051" imgH="2965508" progId="Prism9.Document">
                      <p:embed/>
                      <p:pic>
                        <p:nvPicPr>
                          <p:cNvPr id="2" name="Object 1">
                            <a:extLst>
                              <a:ext uri="{FF2B5EF4-FFF2-40B4-BE49-F238E27FC236}">
                                <a16:creationId xmlns:a16="http://schemas.microsoft.com/office/drawing/2014/main" id="{76D0EED3-CCD0-4B93-3FD4-8A0069A8DDD4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8642830" y="919957"/>
                            <a:ext cx="3325812" cy="23034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" name="Object 2">
                <a:extLst>
                  <a:ext uri="{FF2B5EF4-FFF2-40B4-BE49-F238E27FC236}">
                    <a16:creationId xmlns:a16="http://schemas.microsoft.com/office/drawing/2014/main" id="{C3123E4F-6476-ECC8-700F-4226B3127CA8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2632407" y="926308"/>
              <a:ext cx="3297237" cy="22939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4" imgW="4026317" imgH="2992880" progId="Prism9.Document">
                      <p:embed/>
                    </p:oleObj>
                  </mc:Choice>
                  <mc:Fallback>
                    <p:oleObj name="Prism 9" r:id="rId4" imgW="4026317" imgH="2992880" progId="Prism9.Document">
                      <p:embed/>
                      <p:pic>
                        <p:nvPicPr>
                          <p:cNvPr id="3" name="Object 2">
                            <a:extLst>
                              <a:ext uri="{FF2B5EF4-FFF2-40B4-BE49-F238E27FC236}">
                                <a16:creationId xmlns:a16="http://schemas.microsoft.com/office/drawing/2014/main" id="{C3123E4F-6476-ECC8-700F-4226B3127CA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2632407" y="926308"/>
                            <a:ext cx="3297237" cy="22939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" name="Object 3">
                <a:extLst>
                  <a:ext uri="{FF2B5EF4-FFF2-40B4-BE49-F238E27FC236}">
                    <a16:creationId xmlns:a16="http://schemas.microsoft.com/office/drawing/2014/main" id="{C023EBB6-6A2E-789A-48F3-98A76F97B3DF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5614179" y="913607"/>
              <a:ext cx="3298825" cy="23114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6" imgW="4026317" imgH="2992880" progId="Prism9.Document">
                      <p:embed/>
                    </p:oleObj>
                  </mc:Choice>
                  <mc:Fallback>
                    <p:oleObj name="Prism 9" r:id="rId6" imgW="4026317" imgH="2992880" progId="Prism9.Document">
                      <p:embed/>
                      <p:pic>
                        <p:nvPicPr>
                          <p:cNvPr id="4" name="Object 3">
                            <a:extLst>
                              <a:ext uri="{FF2B5EF4-FFF2-40B4-BE49-F238E27FC236}">
                                <a16:creationId xmlns:a16="http://schemas.microsoft.com/office/drawing/2014/main" id="{C023EBB6-6A2E-789A-48F3-98A76F97B3D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5614179" y="913607"/>
                            <a:ext cx="3298825" cy="23114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Object 4">
                <a:extLst>
                  <a:ext uri="{FF2B5EF4-FFF2-40B4-BE49-F238E27FC236}">
                    <a16:creationId xmlns:a16="http://schemas.microsoft.com/office/drawing/2014/main" id="{A31FCCCD-E0E8-9FC9-A8B2-FAFCD23F044B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-159900" y="943770"/>
              <a:ext cx="3181351" cy="22510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8" imgW="4026317" imgH="2988198" progId="Prism10.Document">
                      <p:embed/>
                    </p:oleObj>
                  </mc:Choice>
                  <mc:Fallback>
                    <p:oleObj name="Prism 10" r:id="rId8" imgW="4026317" imgH="2988198" progId="Prism10.Document">
                      <p:embed/>
                      <p:pic>
                        <p:nvPicPr>
                          <p:cNvPr id="5" name="Object 4">
                            <a:extLst>
                              <a:ext uri="{FF2B5EF4-FFF2-40B4-BE49-F238E27FC236}">
                                <a16:creationId xmlns:a16="http://schemas.microsoft.com/office/drawing/2014/main" id="{A31FCCCD-E0E8-9FC9-A8B2-FAFCD23F044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9"/>
                          <a:stretch>
                            <a:fillRect/>
                          </a:stretch>
                        </p:blipFill>
                        <p:spPr>
                          <a:xfrm>
                            <a:off x="-159900" y="943770"/>
                            <a:ext cx="3181351" cy="22510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7E9E801D-7A6F-2177-B909-DEDAB3449ADF}"/>
                  </a:ext>
                </a:extLst>
              </p:cNvPr>
              <p:cNvSpPr txBox="1"/>
              <p:nvPr/>
            </p:nvSpPr>
            <p:spPr>
              <a:xfrm>
                <a:off x="9530993" y="1402069"/>
                <a:ext cx="1197033" cy="4759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39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GB" sz="1039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GB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=0.43</a:t>
                </a:r>
              </a:p>
              <a:p>
                <a:r>
                  <a:rPr lang="en-GB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p=0.008</a:t>
                </a:r>
                <a:endParaRPr lang="it-IT" sz="1039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8311A407-EBCF-8EEE-1AD6-DE286E3A0964}"/>
                  </a:ext>
                </a:extLst>
              </p:cNvPr>
              <p:cNvSpPr txBox="1"/>
              <p:nvPr/>
            </p:nvSpPr>
            <p:spPr>
              <a:xfrm>
                <a:off x="6424464" y="1402070"/>
                <a:ext cx="1197033" cy="4759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39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GB" sz="1039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GB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=0.54</a:t>
                </a:r>
              </a:p>
              <a:p>
                <a:r>
                  <a:rPr lang="en-GB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p=0.0006</a:t>
                </a:r>
                <a:endParaRPr lang="it-IT" sz="1039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2460C3B9-D5E2-BCCC-F80C-6B60D057841B}"/>
                  </a:ext>
                </a:extLst>
              </p:cNvPr>
              <p:cNvSpPr txBox="1"/>
              <p:nvPr/>
            </p:nvSpPr>
            <p:spPr>
              <a:xfrm>
                <a:off x="3422348" y="1402070"/>
                <a:ext cx="1197033" cy="4759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39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GB" sz="1039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GB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=0.68</a:t>
                </a:r>
              </a:p>
              <a:p>
                <a:r>
                  <a:rPr lang="en-GB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p&lt;0.0001</a:t>
                </a:r>
                <a:endParaRPr lang="it-IT" sz="1039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DDC4E9C0-BB09-9FD5-8905-37D5A7EFA6C4}"/>
                  </a:ext>
                </a:extLst>
              </p:cNvPr>
              <p:cNvSpPr txBox="1"/>
              <p:nvPr/>
            </p:nvSpPr>
            <p:spPr>
              <a:xfrm>
                <a:off x="633304" y="1402069"/>
                <a:ext cx="1197033" cy="4759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39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GB" sz="1039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GB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=0.35</a:t>
                </a:r>
              </a:p>
              <a:p>
                <a:r>
                  <a:rPr lang="en-GB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p=0.031</a:t>
                </a:r>
                <a:endParaRPr lang="it-IT" sz="1039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256E0B0-93E3-2AA8-47CF-D1830439EBB4}"/>
                </a:ext>
              </a:extLst>
            </p:cNvPr>
            <p:cNvSpPr txBox="1"/>
            <p:nvPr/>
          </p:nvSpPr>
          <p:spPr>
            <a:xfrm>
              <a:off x="52368" y="983018"/>
              <a:ext cx="510167" cy="3527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85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4044E406-3615-3CDC-E3BB-472CF5809C24}"/>
              </a:ext>
            </a:extLst>
          </p:cNvPr>
          <p:cNvGrpSpPr/>
          <p:nvPr/>
        </p:nvGrpSpPr>
        <p:grpSpPr>
          <a:xfrm>
            <a:off x="743435" y="2860389"/>
            <a:ext cx="10533214" cy="2060976"/>
            <a:chOff x="-85469" y="3303352"/>
            <a:chExt cx="12164399" cy="2380141"/>
          </a:xfrm>
        </p:grpSpPr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96C6D4BA-87DC-2FE2-99CF-25A7CECFCE6D}"/>
                </a:ext>
              </a:extLst>
            </p:cNvPr>
            <p:cNvGrpSpPr/>
            <p:nvPr/>
          </p:nvGrpSpPr>
          <p:grpSpPr>
            <a:xfrm>
              <a:off x="-85469" y="3303352"/>
              <a:ext cx="12164399" cy="2380141"/>
              <a:chOff x="-85469" y="3303352"/>
              <a:chExt cx="12164399" cy="2380141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4E510B66-F2E0-97F2-75F6-EBDB440D6FBF}"/>
                  </a:ext>
                </a:extLst>
              </p:cNvPr>
              <p:cNvGrpSpPr/>
              <p:nvPr/>
            </p:nvGrpSpPr>
            <p:grpSpPr>
              <a:xfrm>
                <a:off x="8861041" y="3303352"/>
                <a:ext cx="3217889" cy="2317750"/>
                <a:chOff x="-1027966" y="2947974"/>
                <a:chExt cx="3329101" cy="2415425"/>
              </a:xfrm>
            </p:grpSpPr>
            <p:graphicFrame>
              <p:nvGraphicFramePr>
                <p:cNvPr id="11" name="Object 10">
                  <a:extLst>
                    <a:ext uri="{FF2B5EF4-FFF2-40B4-BE49-F238E27FC236}">
                      <a16:creationId xmlns:a16="http://schemas.microsoft.com/office/drawing/2014/main" id="{A9C2D6B8-876F-A03B-49EF-BEF5F365C72D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-1027966" y="2947974"/>
                <a:ext cx="3329101" cy="2415425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10" imgW="4000388" imgH="2965508" progId="Prism10.Document">
                        <p:embed/>
                      </p:oleObj>
                    </mc:Choice>
                    <mc:Fallback>
                      <p:oleObj name="Prism 10" r:id="rId10" imgW="4000388" imgH="2965508" progId="Prism10.Document">
                        <p:embed/>
                        <p:pic>
                          <p:nvPicPr>
                            <p:cNvPr id="11" name="Object 10">
                              <a:extLst>
                                <a:ext uri="{FF2B5EF4-FFF2-40B4-BE49-F238E27FC236}">
                                  <a16:creationId xmlns:a16="http://schemas.microsoft.com/office/drawing/2014/main" id="{A9C2D6B8-876F-A03B-49EF-BEF5F365C72D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1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-1027966" y="2947974"/>
                              <a:ext cx="3329101" cy="2415425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A2EB273C-E9EF-4691-DFAD-0B67052EDB51}"/>
                    </a:ext>
                  </a:extLst>
                </p:cNvPr>
                <p:cNvSpPr txBox="1"/>
                <p:nvPr/>
              </p:nvSpPr>
              <p:spPr>
                <a:xfrm>
                  <a:off x="-297762" y="3391587"/>
                  <a:ext cx="959485" cy="49605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1039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en-AU" sz="1039" baseline="-25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AU" sz="103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=0.55</a:t>
                  </a:r>
                </a:p>
                <a:p>
                  <a:r>
                    <a:rPr lang="en-AU" sz="103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&lt;0.0001</a:t>
                  </a:r>
                </a:p>
              </p:txBody>
            </p:sp>
          </p:grp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A9E0E6E5-9C47-9F2B-EB06-DA10232FBD7C}"/>
                  </a:ext>
                </a:extLst>
              </p:cNvPr>
              <p:cNvGrpSpPr/>
              <p:nvPr/>
            </p:nvGrpSpPr>
            <p:grpSpPr>
              <a:xfrm>
                <a:off x="2717769" y="3349940"/>
                <a:ext cx="3317875" cy="2322920"/>
                <a:chOff x="2692545" y="2818921"/>
                <a:chExt cx="3317875" cy="2322920"/>
              </a:xfrm>
            </p:grpSpPr>
            <p:graphicFrame>
              <p:nvGraphicFramePr>
                <p:cNvPr id="13" name="Object 12">
                  <a:extLst>
                    <a:ext uri="{FF2B5EF4-FFF2-40B4-BE49-F238E27FC236}">
                      <a16:creationId xmlns:a16="http://schemas.microsoft.com/office/drawing/2014/main" id="{4AB9D976-7766-D5A3-B422-72D291FD9E9C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2692545" y="2818921"/>
                <a:ext cx="3317875" cy="2322920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Prism 10" r:id="rId12" imgW="4127155" imgH="2992880" progId="Prism10.Document">
                        <p:embed/>
                      </p:oleObj>
                    </mc:Choice>
                    <mc:Fallback>
                      <p:oleObj name="Prism 10" r:id="rId12" imgW="4127155" imgH="2992880" progId="Prism10.Document">
                        <p:embed/>
                        <p:pic>
                          <p:nvPicPr>
                            <p:cNvPr id="13" name="Object 12">
                              <a:extLst>
                                <a:ext uri="{FF2B5EF4-FFF2-40B4-BE49-F238E27FC236}">
                                  <a16:creationId xmlns:a16="http://schemas.microsoft.com/office/drawing/2014/main" id="{4AB9D976-7766-D5A3-B422-72D291FD9E9C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1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2692545" y="2818921"/>
                              <a:ext cx="3317875" cy="2322920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41C8BEE6-F3D5-5D01-028E-E0B051CB2D18}"/>
                    </a:ext>
                  </a:extLst>
                </p:cNvPr>
                <p:cNvSpPr txBox="1"/>
                <p:nvPr/>
              </p:nvSpPr>
              <p:spPr>
                <a:xfrm>
                  <a:off x="3539310" y="3198008"/>
                  <a:ext cx="927432" cy="47599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AU" sz="1039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en-AU" sz="1039" baseline="-250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S</a:t>
                  </a:r>
                  <a:r>
                    <a:rPr lang="en-AU" sz="103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=0.75</a:t>
                  </a:r>
                </a:p>
                <a:p>
                  <a:r>
                    <a:rPr lang="en-AU" sz="1039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&lt;0.0001</a:t>
                  </a:r>
                </a:p>
              </p:txBody>
            </p:sp>
          </p:grpSp>
          <p:graphicFrame>
            <p:nvGraphicFramePr>
              <p:cNvPr id="15" name="Object 14">
                <a:extLst>
                  <a:ext uri="{FF2B5EF4-FFF2-40B4-BE49-F238E27FC236}">
                    <a16:creationId xmlns:a16="http://schemas.microsoft.com/office/drawing/2014/main" id="{B1C30DDF-C9B3-BF2B-E203-485EF943EAC0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-85469" y="3339307"/>
              <a:ext cx="3240715" cy="234418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4" imgW="4127155" imgH="2992880" progId="Prism10.Document">
                      <p:embed/>
                    </p:oleObj>
                  </mc:Choice>
                  <mc:Fallback>
                    <p:oleObj name="Prism 10" r:id="rId14" imgW="4127155" imgH="2992880" progId="Prism10.Document">
                      <p:embed/>
                      <p:pic>
                        <p:nvPicPr>
                          <p:cNvPr id="15" name="Object 14">
                            <a:extLst>
                              <a:ext uri="{FF2B5EF4-FFF2-40B4-BE49-F238E27FC236}">
                                <a16:creationId xmlns:a16="http://schemas.microsoft.com/office/drawing/2014/main" id="{B1C30DDF-C9B3-BF2B-E203-485EF943EAC0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5"/>
                          <a:stretch>
                            <a:fillRect/>
                          </a:stretch>
                        </p:blipFill>
                        <p:spPr>
                          <a:xfrm>
                            <a:off x="-85469" y="3339307"/>
                            <a:ext cx="3240715" cy="2344186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6" name="Object 15">
                <a:extLst>
                  <a:ext uri="{FF2B5EF4-FFF2-40B4-BE49-F238E27FC236}">
                    <a16:creationId xmlns:a16="http://schemas.microsoft.com/office/drawing/2014/main" id="{B3EA293D-BB95-508D-A010-19EA13693725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5710947" y="3316013"/>
              <a:ext cx="3336560" cy="234418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10" r:id="rId16" imgW="4136159" imgH="2992880" progId="Prism10.Document">
                      <p:embed/>
                    </p:oleObj>
                  </mc:Choice>
                  <mc:Fallback>
                    <p:oleObj name="Prism 10" r:id="rId16" imgW="4136159" imgH="2992880" progId="Prism10.Document">
                      <p:embed/>
                      <p:pic>
                        <p:nvPicPr>
                          <p:cNvPr id="16" name="Object 15">
                            <a:extLst>
                              <a:ext uri="{FF2B5EF4-FFF2-40B4-BE49-F238E27FC236}">
                                <a16:creationId xmlns:a16="http://schemas.microsoft.com/office/drawing/2014/main" id="{B3EA293D-BB95-508D-A010-19EA1369372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7"/>
                          <a:stretch>
                            <a:fillRect/>
                          </a:stretch>
                        </p:blipFill>
                        <p:spPr>
                          <a:xfrm>
                            <a:off x="5710947" y="3316013"/>
                            <a:ext cx="3336560" cy="2344186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7B853172-FA04-9E25-9508-05B4F9B6D1B5}"/>
                  </a:ext>
                </a:extLst>
              </p:cNvPr>
              <p:cNvSpPr txBox="1"/>
              <p:nvPr/>
            </p:nvSpPr>
            <p:spPr>
              <a:xfrm>
                <a:off x="6618929" y="3722249"/>
                <a:ext cx="927432" cy="4759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39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AU" sz="1039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AU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=0.59</a:t>
                </a:r>
              </a:p>
              <a:p>
                <a:r>
                  <a:rPr lang="en-AU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p&lt;0.0001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B56C2888-B609-8164-8A6C-790A1297FE91}"/>
                  </a:ext>
                </a:extLst>
              </p:cNvPr>
              <p:cNvSpPr txBox="1"/>
              <p:nvPr/>
            </p:nvSpPr>
            <p:spPr>
              <a:xfrm>
                <a:off x="739632" y="3729027"/>
                <a:ext cx="927432" cy="4759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039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en-AU" sz="1039" baseline="-25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n-AU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=0.72</a:t>
                </a:r>
              </a:p>
              <a:p>
                <a:r>
                  <a:rPr lang="en-AU" sz="1039" dirty="0">
                    <a:latin typeface="Arial" panose="020B0604020202020204" pitchFamily="34" charset="0"/>
                    <a:cs typeface="Arial" panose="020B0604020202020204" pitchFamily="34" charset="0"/>
                  </a:rPr>
                  <a:t>p&lt;0.0001</a:t>
                </a:r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AFC0D2D-5852-220F-C4D8-17976662AED9}"/>
                </a:ext>
              </a:extLst>
            </p:cNvPr>
            <p:cNvSpPr txBox="1"/>
            <p:nvPr/>
          </p:nvSpPr>
          <p:spPr>
            <a:xfrm>
              <a:off x="52367" y="3313907"/>
              <a:ext cx="510167" cy="3527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85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id="{1E38A4D8-3281-4369-6308-825127F02846}"/>
              </a:ext>
            </a:extLst>
          </p:cNvPr>
          <p:cNvSpPr txBox="1"/>
          <p:nvPr/>
        </p:nvSpPr>
        <p:spPr>
          <a:xfrm>
            <a:off x="144512" y="5609955"/>
            <a:ext cx="11902975" cy="7409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693"/>
              </a:spcAft>
            </a:pP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Correlation analysis of selected parameters in naïve CD8</a:t>
            </a:r>
            <a:r>
              <a:rPr lang="en-AU" sz="1000" b="1" kern="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 cell subsets against age. 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equency of (</a:t>
            </a: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CX3CR1</a:t>
            </a:r>
            <a:r>
              <a:rPr lang="en-AU" sz="1000" kern="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(</a:t>
            </a: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SA-β-gal</a:t>
            </a:r>
            <a:r>
              <a:rPr lang="en-AU" sz="1000" kern="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within N</a:t>
            </a:r>
            <a:r>
              <a:rPr lang="en-AU" sz="1000" kern="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CR7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</a:t>
            </a:r>
            <a:r>
              <a:rPr lang="en-AU" sz="1000" kern="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8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</a:t>
            </a:r>
            <a:r>
              <a:rPr lang="en-AU" sz="1000" kern="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7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N</a:t>
            </a:r>
            <a:r>
              <a:rPr lang="en-AU" sz="1000" kern="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N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D8</a:t>
            </a:r>
            <a:r>
              <a:rPr lang="en-AU" sz="1000" kern="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 cells in relationship with age. Spearman correlation coefficients (</a:t>
            </a:r>
            <a:r>
              <a:rPr lang="en-AU" sz="1000" kern="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AU" sz="1000" kern="100" baseline="-250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p values are shown in the graphs. Spearman correlation, n=38. </a:t>
            </a:r>
            <a:endParaRPr lang="de-AT" sz="1000" kern="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693"/>
              </a:spcAft>
            </a:pPr>
            <a:r>
              <a:rPr lang="en-AU" sz="952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de-AT" sz="952" kern="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87358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4C6CA3C-05A3-089F-28EB-446FCFBA22C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5564925"/>
              </p:ext>
            </p:extLst>
          </p:nvPr>
        </p:nvGraphicFramePr>
        <p:xfrm>
          <a:off x="367192" y="428625"/>
          <a:ext cx="2057400" cy="2546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462248" imgH="3047623" progId="Prism10.Document">
                  <p:embed/>
                </p:oleObj>
              </mc:Choice>
              <mc:Fallback>
                <p:oleObj name="Prism 10" r:id="rId2" imgW="2462248" imgH="3047623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1AA37E95-649B-F00F-CED3-7BDCB0C97E0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67192" y="428625"/>
                        <a:ext cx="2057400" cy="2546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C4565C4-7B3B-C6A1-0621-E5B59B1FC1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988802"/>
              </p:ext>
            </p:extLst>
          </p:nvPr>
        </p:nvGraphicFramePr>
        <p:xfrm>
          <a:off x="2424592" y="428625"/>
          <a:ext cx="2057400" cy="2538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462248" imgH="3038620" progId="Prism10.Document">
                  <p:embed/>
                </p:oleObj>
              </mc:Choice>
              <mc:Fallback>
                <p:oleObj name="Prism 10" r:id="rId4" imgW="2462248" imgH="3038620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C4C6CA3C-05A3-089F-28EB-446FCFBA22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24592" y="428625"/>
                        <a:ext cx="2057400" cy="2538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52DB9BF-D7C1-7FDE-09E9-DE2D52FB11EF}"/>
              </a:ext>
            </a:extLst>
          </p:cNvPr>
          <p:cNvSpPr txBox="1"/>
          <p:nvPr/>
        </p:nvSpPr>
        <p:spPr>
          <a:xfrm>
            <a:off x="367192" y="428625"/>
            <a:ext cx="441756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385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E185FD0-C486-EB63-B1F5-80B5185B6AA0}"/>
              </a:ext>
            </a:extLst>
          </p:cNvPr>
          <p:cNvSpPr txBox="1"/>
          <p:nvPr/>
        </p:nvSpPr>
        <p:spPr>
          <a:xfrm>
            <a:off x="2385341" y="428625"/>
            <a:ext cx="441756" cy="305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385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0442D98-40D9-B515-7BB8-3E5AAF90E2AB}"/>
              </a:ext>
            </a:extLst>
          </p:cNvPr>
          <p:cNvSpPr txBox="1"/>
          <p:nvPr/>
        </p:nvSpPr>
        <p:spPr>
          <a:xfrm>
            <a:off x="4857135" y="1360143"/>
            <a:ext cx="722671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693"/>
              </a:spcAft>
            </a:pP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 Contamination of CD28</a:t>
            </a:r>
            <a:r>
              <a:rPr lang="en-AU" sz="1000" b="1" kern="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5RA</a:t>
            </a:r>
            <a:r>
              <a:rPr lang="en-AU" sz="1000" b="1" kern="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CD27</a:t>
            </a:r>
            <a:r>
              <a:rPr lang="en-AU" sz="1000" b="1" kern="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5RA</a:t>
            </a:r>
            <a:r>
              <a:rPr lang="en-AU" sz="1000" b="1" kern="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thin naïve CD8</a:t>
            </a:r>
            <a:r>
              <a:rPr lang="en-AU" sz="1000" b="1" kern="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 cell subsets. 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equency of (</a:t>
            </a: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kumimoji="0" lang="en-AU" sz="10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8</a:t>
            </a:r>
            <a:r>
              <a:rPr kumimoji="0" lang="en-AU" sz="1000" i="0" u="none" strike="noStrike" kern="1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kumimoji="0" lang="en-AU" sz="10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5RA</a:t>
            </a:r>
            <a:r>
              <a:rPr kumimoji="0" lang="en-AU" sz="1000" i="0" u="none" strike="noStrike" kern="1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kumimoji="0" lang="en-AU" sz="10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s within N</a:t>
            </a:r>
            <a:r>
              <a:rPr kumimoji="0" lang="en-AU" sz="1000" i="0" u="none" strike="noStrike" kern="1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CR7</a:t>
            </a:r>
            <a:r>
              <a:rPr kumimoji="0" lang="en-AU" sz="100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N</a:t>
            </a:r>
            <a:r>
              <a:rPr kumimoji="0" lang="en-AU" sz="1000" i="0" u="none" strike="noStrike" kern="100" cap="none" spc="0" normalizeH="0" baseline="-25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7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(</a:t>
            </a:r>
            <a:r>
              <a:rPr lang="en-AU" sz="10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kumimoji="0" lang="en-AU" sz="10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7</a:t>
            </a:r>
            <a:r>
              <a:rPr kumimoji="0" lang="en-AU" sz="1000" b="0" i="0" u="none" strike="noStrike" kern="1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kumimoji="0" lang="en-AU" sz="10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45RA</a:t>
            </a:r>
            <a:r>
              <a:rPr kumimoji="0" lang="en-AU" sz="1000" b="0" i="0" u="none" strike="noStrike" kern="1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kumimoji="0" lang="en-AU" sz="10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s within N</a:t>
            </a:r>
            <a:r>
              <a:rPr lang="en-AU" sz="1000" kern="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CR7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N</a:t>
            </a:r>
            <a:r>
              <a:rPr lang="en-AU" sz="1000" kern="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28</a:t>
            </a:r>
            <a:r>
              <a:rPr lang="en-AU" sz="10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AU" sz="952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de-AT" sz="952" kern="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5293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4</Words>
  <Application>Microsoft Office PowerPoint</Application>
  <PresentationFormat>Widescreen</PresentationFormat>
  <Paragraphs>54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Aptos</vt:lpstr>
      <vt:lpstr>Aptos Display</vt:lpstr>
      <vt:lpstr>Arial</vt:lpstr>
      <vt:lpstr>Calibri</vt:lpstr>
      <vt:lpstr>Office Theme</vt:lpstr>
      <vt:lpstr>Prism 10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uca Pangrazzi</dc:creator>
  <cp:lastModifiedBy>Luca Pangrazzi</cp:lastModifiedBy>
  <cp:revision>11</cp:revision>
  <dcterms:created xsi:type="dcterms:W3CDTF">2025-02-26T15:03:15Z</dcterms:created>
  <dcterms:modified xsi:type="dcterms:W3CDTF">2026-01-12T10:35:32Z</dcterms:modified>
</cp:coreProperties>
</file>